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64" autoAdjust="0"/>
    <p:restoredTop sz="94660"/>
  </p:normalViewPr>
  <p:slideViewPr>
    <p:cSldViewPr snapToGrid="0">
      <p:cViewPr>
        <p:scale>
          <a:sx n="100" d="100"/>
          <a:sy n="100" d="100"/>
        </p:scale>
        <p:origin x="1901" y="-13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060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5663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2478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1702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153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9610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8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13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768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37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9614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9CABD-508A-4926-931F-27C91004E358}" type="datetimeFigureOut">
              <a:rPr lang="en-GB" smtClean="0"/>
              <a:t>08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7B303-5CFF-4C28-A980-1CC8E62657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606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9683" y="133350"/>
            <a:ext cx="2671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8149034"/>
              </p:ext>
            </p:extLst>
          </p:nvPr>
        </p:nvGraphicFramePr>
        <p:xfrm>
          <a:off x="1208432" y="993960"/>
          <a:ext cx="2420292" cy="1706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4840584" imgH="3412099" progId="Prism6.Document">
                  <p:embed/>
                </p:oleObj>
              </mc:Choice>
              <mc:Fallback>
                <p:oleObj name="Prism 6" r:id="rId2" imgW="4840584" imgH="341209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08432" y="993960"/>
                        <a:ext cx="2420292" cy="1706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4060314"/>
              </p:ext>
            </p:extLst>
          </p:nvPr>
        </p:nvGraphicFramePr>
        <p:xfrm>
          <a:off x="3573065" y="1048794"/>
          <a:ext cx="2039809" cy="1596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4079617" imgH="3192766" progId="Prism6.Document">
                  <p:embed/>
                </p:oleObj>
              </mc:Choice>
              <mc:Fallback>
                <p:oleObj name="Prism 6" r:id="rId4" imgW="4079617" imgH="319276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73065" y="1048794"/>
                        <a:ext cx="2039809" cy="1596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-8831" y="1151593"/>
            <a:ext cx="2217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inding (A 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492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6439985"/>
              </p:ext>
            </p:extLst>
          </p:nvPr>
        </p:nvGraphicFramePr>
        <p:xfrm>
          <a:off x="2382838" y="3089275"/>
          <a:ext cx="2039937" cy="157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4079617" imgH="3147026" progId="Prism6.Document">
                  <p:embed/>
                </p:oleObj>
              </mc:Choice>
              <mc:Fallback>
                <p:oleObj name="Prism 6" r:id="rId6" imgW="4079617" imgH="314702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82838" y="3089275"/>
                        <a:ext cx="2039937" cy="1571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1178937" y="3060483"/>
            <a:ext cx="2217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inding (A 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492n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51113" y="748740"/>
            <a:ext cx="497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89992" y="2821956"/>
            <a:ext cx="497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6D6C32-CD24-5B74-0EA6-1B1A9778C61B}"/>
              </a:ext>
            </a:extLst>
          </p:cNvPr>
          <p:cNvSpPr txBox="1"/>
          <p:nvPr/>
        </p:nvSpPr>
        <p:spPr>
          <a:xfrm>
            <a:off x="523702" y="5303520"/>
            <a:ext cx="587709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ole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e’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ron and residual hydrogen peroxide for increased functional impact of heme-ox on human IgG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Zn(II) protoporphyrin IX was diluted to 1 mM and treated with 25 mM H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olyclonal IgG was diluted to 6.7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in PBS and exposed to increasing concentrations of Zn(II) protoporphyrin IX – peroxide (0, 0.125 – 32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. The reactivity of human IgG to immobilized human apo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oglob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ft panel) and human factor IX (right panel) was evaluated by ELISA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inding of human IgG pre-incubated at 6.7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with increasing concentrations of H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0, 3.9 – 1000 mM) to factor IX and apo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oglob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interaction analyses were performed with IgG diluted to 0.67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in PBS-T. Each point represents mean optical density ±SD of triplicate wells.</a:t>
            </a:r>
            <a:endParaRPr lang="en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1448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6</TotalTime>
  <Words>177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D DIMITROV</dc:creator>
  <cp:lastModifiedBy>MDPI</cp:lastModifiedBy>
  <cp:revision>89</cp:revision>
  <cp:lastPrinted>2016-10-18T14:21:35Z</cp:lastPrinted>
  <dcterms:created xsi:type="dcterms:W3CDTF">2016-07-15T09:43:11Z</dcterms:created>
  <dcterms:modified xsi:type="dcterms:W3CDTF">2023-02-08T12:55:33Z</dcterms:modified>
</cp:coreProperties>
</file>